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51" d="100"/>
          <a:sy n="51" d="100"/>
        </p:scale>
        <p:origin x="234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KAGAWA Tomohiro" userId="d74b3e309c52a267" providerId="LiveId" clId="{5886FCBB-F41C-42F7-933B-7BDE3AE3053C}"/>
    <pc:docChg chg="undo custSel modSld">
      <pc:chgData name="OKAGAWA Tomohiro" userId="d74b3e309c52a267" providerId="LiveId" clId="{5886FCBB-F41C-42F7-933B-7BDE3AE3053C}" dt="2021-12-28T02:15:46.007" v="772" actId="1038"/>
      <pc:docMkLst>
        <pc:docMk/>
      </pc:docMkLst>
      <pc:sldChg chg="addSp modSp mod">
        <pc:chgData name="OKAGAWA Tomohiro" userId="d74b3e309c52a267" providerId="LiveId" clId="{5886FCBB-F41C-42F7-933B-7BDE3AE3053C}" dt="2021-12-28T02:15:46.007" v="772" actId="1038"/>
        <pc:sldMkLst>
          <pc:docMk/>
          <pc:sldMk cId="2879998273" sldId="256"/>
        </pc:sldMkLst>
        <pc:spChg chg="add mod">
          <ac:chgData name="OKAGAWA Tomohiro" userId="d74b3e309c52a267" providerId="LiveId" clId="{5886FCBB-F41C-42F7-933B-7BDE3AE3053C}" dt="2021-12-28T01:56:57.007" v="38" actId="1076"/>
          <ac:spMkLst>
            <pc:docMk/>
            <pc:sldMk cId="2879998273" sldId="256"/>
            <ac:spMk id="3" creationId="{3C71BA40-4C5F-4E3E-9FDF-10D59AB43C66}"/>
          </ac:spMkLst>
        </pc:spChg>
        <pc:graphicFrameChg chg="mod modGraphic">
          <ac:chgData name="OKAGAWA Tomohiro" userId="d74b3e309c52a267" providerId="LiveId" clId="{5886FCBB-F41C-42F7-933B-7BDE3AE3053C}" dt="2021-12-28T02:15:46.007" v="772" actId="1038"/>
          <ac:graphicFrameMkLst>
            <pc:docMk/>
            <pc:sldMk cId="2879998273" sldId="256"/>
            <ac:graphicFrameMk id="5" creationId="{28AA4524-C1F8-4974-A5E6-93C4C8CE70A8}"/>
          </ac:graphicFrameMkLst>
        </pc:graphicFrameChg>
      </pc:sldChg>
      <pc:sldChg chg="addSp modSp mod">
        <pc:chgData name="OKAGAWA Tomohiro" userId="d74b3e309c52a267" providerId="LiveId" clId="{5886FCBB-F41C-42F7-933B-7BDE3AE3053C}" dt="2021-12-28T02:15:39.635" v="763" actId="12788"/>
        <pc:sldMkLst>
          <pc:docMk/>
          <pc:sldMk cId="2176500321" sldId="257"/>
        </pc:sldMkLst>
        <pc:spChg chg="mod">
          <ac:chgData name="OKAGAWA Tomohiro" userId="d74b3e309c52a267" providerId="LiveId" clId="{5886FCBB-F41C-42F7-933B-7BDE3AE3053C}" dt="2021-12-28T01:59:20.726" v="105" actId="552"/>
          <ac:spMkLst>
            <pc:docMk/>
            <pc:sldMk cId="2176500321" sldId="257"/>
            <ac:spMk id="8" creationId="{CECC3651-6356-42BA-90D4-D53D8AF637D3}"/>
          </ac:spMkLst>
        </pc:spChg>
        <pc:spChg chg="mod">
          <ac:chgData name="OKAGAWA Tomohiro" userId="d74b3e309c52a267" providerId="LiveId" clId="{5886FCBB-F41C-42F7-933B-7BDE3AE3053C}" dt="2021-12-28T01:59:28.193" v="107" actId="14100"/>
          <ac:spMkLst>
            <pc:docMk/>
            <pc:sldMk cId="2176500321" sldId="257"/>
            <ac:spMk id="9" creationId="{847F998F-4C07-4B5A-A9F3-01507E6D6A75}"/>
          </ac:spMkLst>
        </pc:spChg>
        <pc:spChg chg="mod">
          <ac:chgData name="OKAGAWA Tomohiro" userId="d74b3e309c52a267" providerId="LiveId" clId="{5886FCBB-F41C-42F7-933B-7BDE3AE3053C}" dt="2021-12-28T01:59:20.726" v="105" actId="552"/>
          <ac:spMkLst>
            <pc:docMk/>
            <pc:sldMk cId="2176500321" sldId="257"/>
            <ac:spMk id="10" creationId="{FDE252EE-D3A8-4DB5-8025-9A869134AB24}"/>
          </ac:spMkLst>
        </pc:spChg>
        <pc:spChg chg="mod">
          <ac:chgData name="OKAGAWA Tomohiro" userId="d74b3e309c52a267" providerId="LiveId" clId="{5886FCBB-F41C-42F7-933B-7BDE3AE3053C}" dt="2021-12-28T01:59:24.992" v="106" actId="552"/>
          <ac:spMkLst>
            <pc:docMk/>
            <pc:sldMk cId="2176500321" sldId="257"/>
            <ac:spMk id="11" creationId="{182492F5-D548-4006-A7D9-7D539CD3BF35}"/>
          </ac:spMkLst>
        </pc:spChg>
        <pc:spChg chg="add mod">
          <ac:chgData name="OKAGAWA Tomohiro" userId="d74b3e309c52a267" providerId="LiveId" clId="{5886FCBB-F41C-42F7-933B-7BDE3AE3053C}" dt="2021-12-28T02:15:39.635" v="763" actId="12788"/>
          <ac:spMkLst>
            <pc:docMk/>
            <pc:sldMk cId="2176500321" sldId="257"/>
            <ac:spMk id="12" creationId="{388C4F0B-C68F-487B-8066-CF13BA86AD47}"/>
          </ac:spMkLst>
        </pc:spChg>
      </pc:sldChg>
      <pc:sldChg chg="addSp modSp mod">
        <pc:chgData name="OKAGAWA Tomohiro" userId="d74b3e309c52a267" providerId="LiveId" clId="{5886FCBB-F41C-42F7-933B-7BDE3AE3053C}" dt="2021-12-28T02:15:34.905" v="762" actId="12788"/>
        <pc:sldMkLst>
          <pc:docMk/>
          <pc:sldMk cId="3092454316" sldId="258"/>
        </pc:sldMkLst>
        <pc:spChg chg="mod">
          <ac:chgData name="OKAGAWA Tomohiro" userId="d74b3e309c52a267" providerId="LiveId" clId="{5886FCBB-F41C-42F7-933B-7BDE3AE3053C}" dt="2021-12-28T02:02:50.654" v="216" actId="1035"/>
          <ac:spMkLst>
            <pc:docMk/>
            <pc:sldMk cId="3092454316" sldId="258"/>
            <ac:spMk id="5" creationId="{AD53BC56-9CD9-4537-BC22-509DD5F5CF28}"/>
          </ac:spMkLst>
        </pc:spChg>
        <pc:spChg chg="mod">
          <ac:chgData name="OKAGAWA Tomohiro" userId="d74b3e309c52a267" providerId="LiveId" clId="{5886FCBB-F41C-42F7-933B-7BDE3AE3053C}" dt="2021-12-28T02:02:50.654" v="216" actId="1035"/>
          <ac:spMkLst>
            <pc:docMk/>
            <pc:sldMk cId="3092454316" sldId="258"/>
            <ac:spMk id="7" creationId="{06A4BC64-B92B-46C5-B952-67D03CDA8590}"/>
          </ac:spMkLst>
        </pc:spChg>
        <pc:spChg chg="mod">
          <ac:chgData name="OKAGAWA Tomohiro" userId="d74b3e309c52a267" providerId="LiveId" clId="{5886FCBB-F41C-42F7-933B-7BDE3AE3053C}" dt="2021-12-28T02:10:28.233" v="569" actId="1035"/>
          <ac:spMkLst>
            <pc:docMk/>
            <pc:sldMk cId="3092454316" sldId="258"/>
            <ac:spMk id="9" creationId="{FC20F88B-779B-4B8E-9592-36D12D5934CB}"/>
          </ac:spMkLst>
        </pc:spChg>
        <pc:spChg chg="add mod">
          <ac:chgData name="OKAGAWA Tomohiro" userId="d74b3e309c52a267" providerId="LiveId" clId="{5886FCBB-F41C-42F7-933B-7BDE3AE3053C}" dt="2021-12-28T02:15:34.905" v="762" actId="12788"/>
          <ac:spMkLst>
            <pc:docMk/>
            <pc:sldMk cId="3092454316" sldId="258"/>
            <ac:spMk id="12" creationId="{03367787-1E0C-454E-9F9C-AD79F92BB878}"/>
          </ac:spMkLst>
        </pc:spChg>
        <pc:spChg chg="mod">
          <ac:chgData name="OKAGAWA Tomohiro" userId="d74b3e309c52a267" providerId="LiveId" clId="{5886FCBB-F41C-42F7-933B-7BDE3AE3053C}" dt="2021-12-28T02:10:28.233" v="569" actId="1035"/>
          <ac:spMkLst>
            <pc:docMk/>
            <pc:sldMk cId="3092454316" sldId="258"/>
            <ac:spMk id="13" creationId="{04C3066E-2124-4B3A-A634-79A06F62DFAE}"/>
          </ac:spMkLst>
        </pc:spChg>
        <pc:spChg chg="mod">
          <ac:chgData name="OKAGAWA Tomohiro" userId="d74b3e309c52a267" providerId="LiveId" clId="{5886FCBB-F41C-42F7-933B-7BDE3AE3053C}" dt="2021-12-28T02:10:28.233" v="569" actId="1035"/>
          <ac:spMkLst>
            <pc:docMk/>
            <pc:sldMk cId="3092454316" sldId="258"/>
            <ac:spMk id="15" creationId="{B5C586AD-A457-4A2F-B5AB-05587D506C9B}"/>
          </ac:spMkLst>
        </pc:spChg>
        <pc:graphicFrameChg chg="mod modGraphic">
          <ac:chgData name="OKAGAWA Tomohiro" userId="d74b3e309c52a267" providerId="LiveId" clId="{5886FCBB-F41C-42F7-933B-7BDE3AE3053C}" dt="2021-12-28T02:10:20.074" v="549" actId="14100"/>
          <ac:graphicFrameMkLst>
            <pc:docMk/>
            <pc:sldMk cId="3092454316" sldId="258"/>
            <ac:graphicFrameMk id="4" creationId="{51D5F3E7-2D88-4977-9F1F-E68466E57757}"/>
          </ac:graphicFrameMkLst>
        </pc:graphicFrameChg>
        <pc:graphicFrameChg chg="mod modGraphic">
          <ac:chgData name="OKAGAWA Tomohiro" userId="d74b3e309c52a267" providerId="LiveId" clId="{5886FCBB-F41C-42F7-933B-7BDE3AE3053C}" dt="2021-12-28T02:10:20.074" v="549" actId="14100"/>
          <ac:graphicFrameMkLst>
            <pc:docMk/>
            <pc:sldMk cId="3092454316" sldId="258"/>
            <ac:graphicFrameMk id="6" creationId="{8D9A3B75-ED18-42AC-BA85-8E4D135AE787}"/>
          </ac:graphicFrameMkLst>
        </pc:graphicFrameChg>
        <pc:graphicFrameChg chg="mod modGraphic">
          <ac:chgData name="OKAGAWA Tomohiro" userId="d74b3e309c52a267" providerId="LiveId" clId="{5886FCBB-F41C-42F7-933B-7BDE3AE3053C}" dt="2021-12-28T02:10:28.233" v="569" actId="1035"/>
          <ac:graphicFrameMkLst>
            <pc:docMk/>
            <pc:sldMk cId="3092454316" sldId="258"/>
            <ac:graphicFrameMk id="10" creationId="{2F66BED3-B3FF-4B8B-ADB5-60003887B286}"/>
          </ac:graphicFrameMkLst>
        </pc:graphicFrameChg>
        <pc:graphicFrameChg chg="mod modGraphic">
          <ac:chgData name="OKAGAWA Tomohiro" userId="d74b3e309c52a267" providerId="LiveId" clId="{5886FCBB-F41C-42F7-933B-7BDE3AE3053C}" dt="2021-12-28T02:10:28.233" v="569" actId="1035"/>
          <ac:graphicFrameMkLst>
            <pc:docMk/>
            <pc:sldMk cId="3092454316" sldId="258"/>
            <ac:graphicFrameMk id="11" creationId="{DF1EE0C2-391D-4AF4-848F-B89D1098CCD9}"/>
          </ac:graphicFrameMkLst>
        </pc:graphicFrameChg>
        <pc:graphicFrameChg chg="mod modGraphic">
          <ac:chgData name="OKAGAWA Tomohiro" userId="d74b3e309c52a267" providerId="LiveId" clId="{5886FCBB-F41C-42F7-933B-7BDE3AE3053C}" dt="2021-12-28T02:10:28.233" v="569" actId="1035"/>
          <ac:graphicFrameMkLst>
            <pc:docMk/>
            <pc:sldMk cId="3092454316" sldId="258"/>
            <ac:graphicFrameMk id="14" creationId="{633FAB34-FE47-4EF9-B7B0-908C0DEE818E}"/>
          </ac:graphicFrameMkLst>
        </pc:graphicFrameChg>
      </pc:sldChg>
      <pc:sldChg chg="addSp modSp mod">
        <pc:chgData name="OKAGAWA Tomohiro" userId="d74b3e309c52a267" providerId="LiveId" clId="{5886FCBB-F41C-42F7-933B-7BDE3AE3053C}" dt="2021-12-28T02:15:30.670" v="761" actId="12788"/>
        <pc:sldMkLst>
          <pc:docMk/>
          <pc:sldMk cId="4162683584" sldId="259"/>
        </pc:sldMkLst>
        <pc:spChg chg="mod">
          <ac:chgData name="OKAGAWA Tomohiro" userId="d74b3e309c52a267" providerId="LiveId" clId="{5886FCBB-F41C-42F7-933B-7BDE3AE3053C}" dt="2021-12-28T02:14:40.539" v="744" actId="552"/>
          <ac:spMkLst>
            <pc:docMk/>
            <pc:sldMk cId="4162683584" sldId="259"/>
            <ac:spMk id="10" creationId="{FDE252EE-D3A8-4DB5-8025-9A869134AB24}"/>
          </ac:spMkLst>
        </pc:spChg>
        <pc:spChg chg="add mod">
          <ac:chgData name="OKAGAWA Tomohiro" userId="d74b3e309c52a267" providerId="LiveId" clId="{5886FCBB-F41C-42F7-933B-7BDE3AE3053C}" dt="2021-12-28T02:15:30.670" v="761" actId="12788"/>
          <ac:spMkLst>
            <pc:docMk/>
            <pc:sldMk cId="4162683584" sldId="259"/>
            <ac:spMk id="11" creationId="{110936BD-A3DB-4F7C-AF31-3592F0EA6EB6}"/>
          </ac:spMkLst>
        </pc:spChg>
        <pc:spChg chg="mod">
          <ac:chgData name="OKAGAWA Tomohiro" userId="d74b3e309c52a267" providerId="LiveId" clId="{5886FCBB-F41C-42F7-933B-7BDE3AE3053C}" dt="2021-12-28T02:14:40.539" v="744" actId="552"/>
          <ac:spMkLst>
            <pc:docMk/>
            <pc:sldMk cId="4162683584" sldId="259"/>
            <ac:spMk id="15" creationId="{917B32FB-9B87-4C4D-AA9B-FFC3E39069AA}"/>
          </ac:spMkLst>
        </pc:spChg>
        <pc:spChg chg="mod">
          <ac:chgData name="OKAGAWA Tomohiro" userId="d74b3e309c52a267" providerId="LiveId" clId="{5886FCBB-F41C-42F7-933B-7BDE3AE3053C}" dt="2021-12-28T02:14:35.646" v="743" actId="552"/>
          <ac:spMkLst>
            <pc:docMk/>
            <pc:sldMk cId="4162683584" sldId="259"/>
            <ac:spMk id="16" creationId="{AD5C1B79-42DB-4284-B402-5406663A737A}"/>
          </ac:spMkLst>
        </pc:spChg>
        <pc:spChg chg="mod">
          <ac:chgData name="OKAGAWA Tomohiro" userId="d74b3e309c52a267" providerId="LiveId" clId="{5886FCBB-F41C-42F7-933B-7BDE3AE3053C}" dt="2021-12-28T02:14:35.646" v="743" actId="552"/>
          <ac:spMkLst>
            <pc:docMk/>
            <pc:sldMk cId="4162683584" sldId="259"/>
            <ac:spMk id="17" creationId="{D41489B0-161B-4390-B14D-AF376C68EF15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99837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21581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8270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89174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2207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59791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3272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351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5750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56114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84113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27BCE0-7016-4323-923E-C5BFC6B93F60}" type="datetimeFigureOut">
              <a:rPr kumimoji="1" lang="ja-JP" altLang="en-US" smtClean="0"/>
              <a:t>2022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B34395-28C6-416D-8A19-16A0FD6E39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20816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51D5F3E7-2D88-4977-9F1F-E68466E5775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72935815"/>
              </p:ext>
            </p:extLst>
          </p:nvPr>
        </p:nvGraphicFramePr>
        <p:xfrm>
          <a:off x="799170" y="433772"/>
          <a:ext cx="1981200" cy="1606230"/>
        </p:xfrm>
        <a:graphic>
          <a:graphicData uri="http://schemas.openxmlformats.org/drawingml/2006/table">
            <a:tbl>
              <a:tblPr/>
              <a:tblGrid>
                <a:gridCol w="660400">
                  <a:extLst>
                    <a:ext uri="{9D8B030D-6E8A-4147-A177-3AD203B41FA5}">
                      <a16:colId xmlns:a16="http://schemas.microsoft.com/office/drawing/2014/main" val="1461170723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1226607111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3785121735"/>
                    </a:ext>
                  </a:extLst>
                </a:gridCol>
              </a:tblGrid>
              <a:tr h="20493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ample #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MSO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stradiol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896448"/>
                  </a:ext>
                </a:extLst>
              </a:tr>
              <a:tr h="20493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2.3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5.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6736378"/>
                  </a:ext>
                </a:extLst>
              </a:tr>
              <a:tr h="19939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7.4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3292329"/>
                  </a:ext>
                </a:extLst>
              </a:tr>
              <a:tr h="19939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4.4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3877734"/>
                  </a:ext>
                </a:extLst>
              </a:tr>
              <a:tr h="19939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0.7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3996976"/>
                  </a:ext>
                </a:extLst>
              </a:tr>
              <a:tr h="19939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0.6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8061886"/>
                  </a:ext>
                </a:extLst>
              </a:tr>
              <a:tr h="19939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6.5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2313289"/>
                  </a:ext>
                </a:extLst>
              </a:tr>
              <a:tr h="19939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8.6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6554582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D53BC56-9CD9-4537-BC22-509DD5F5CF28}"/>
              </a:ext>
            </a:extLst>
          </p:cNvPr>
          <p:cNvSpPr txBox="1"/>
          <p:nvPr/>
        </p:nvSpPr>
        <p:spPr>
          <a:xfrm>
            <a:off x="167269" y="73304"/>
            <a:ext cx="32387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IFN-γ (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: BLV-uninfected cattle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8D9A3B75-ED18-42AC-BA85-8E4D135AE78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98966558"/>
              </p:ext>
            </p:extLst>
          </p:nvPr>
        </p:nvGraphicFramePr>
        <p:xfrm>
          <a:off x="4077632" y="433772"/>
          <a:ext cx="1981200" cy="1606230"/>
        </p:xfrm>
        <a:graphic>
          <a:graphicData uri="http://schemas.openxmlformats.org/drawingml/2006/table">
            <a:tbl>
              <a:tblPr/>
              <a:tblGrid>
                <a:gridCol w="660400">
                  <a:extLst>
                    <a:ext uri="{9D8B030D-6E8A-4147-A177-3AD203B41FA5}">
                      <a16:colId xmlns:a16="http://schemas.microsoft.com/office/drawing/2014/main" val="882373329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2560912087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2831819278"/>
                    </a:ext>
                  </a:extLst>
                </a:gridCol>
              </a:tblGrid>
              <a:tr h="20493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ample #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MSO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stradiol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1826694"/>
                  </a:ext>
                </a:extLst>
              </a:tr>
              <a:tr h="20493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61.5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39.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2615240"/>
                  </a:ext>
                </a:extLst>
              </a:tr>
              <a:tr h="19939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68.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08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4988429"/>
                  </a:ext>
                </a:extLst>
              </a:tr>
              <a:tr h="19939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04.6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19.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9020437"/>
                  </a:ext>
                </a:extLst>
              </a:tr>
              <a:tr h="19939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35.7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57.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6134609"/>
                  </a:ext>
                </a:extLst>
              </a:tr>
              <a:tr h="19939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83.8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87.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8530604"/>
                  </a:ext>
                </a:extLst>
              </a:tr>
              <a:tr h="19939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30.7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7.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8268233"/>
                  </a:ext>
                </a:extLst>
              </a:tr>
              <a:tr h="19939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47.4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58.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2608159"/>
                  </a:ext>
                </a:extLst>
              </a:tr>
            </a:tbl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6A4BC64-B92B-46C5-B952-67D03CDA8590}"/>
              </a:ext>
            </a:extLst>
          </p:cNvPr>
          <p:cNvSpPr txBox="1"/>
          <p:nvPr/>
        </p:nvSpPr>
        <p:spPr>
          <a:xfrm>
            <a:off x="3591936" y="73304"/>
            <a:ext cx="30987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IFN-γ (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: BLV-infected cattle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C20F88B-779B-4B8E-9592-36D12D5934CB}"/>
              </a:ext>
            </a:extLst>
          </p:cNvPr>
          <p:cNvSpPr txBox="1"/>
          <p:nvPr/>
        </p:nvSpPr>
        <p:spPr>
          <a:xfrm>
            <a:off x="167269" y="2184052"/>
            <a:ext cx="29525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kumimoji="1"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X2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(relative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0" name="表 9">
            <a:extLst>
              <a:ext uri="{FF2B5EF4-FFF2-40B4-BE49-F238E27FC236}">
                <a16:creationId xmlns:a16="http://schemas.microsoft.com/office/drawing/2014/main" id="{2F66BED3-B3FF-4B8B-ADB5-60003887B28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65222512"/>
              </p:ext>
            </p:extLst>
          </p:nvPr>
        </p:nvGraphicFramePr>
        <p:xfrm>
          <a:off x="799170" y="2488234"/>
          <a:ext cx="1981200" cy="2044858"/>
        </p:xfrm>
        <a:graphic>
          <a:graphicData uri="http://schemas.openxmlformats.org/drawingml/2006/table">
            <a:tbl>
              <a:tblPr/>
              <a:tblGrid>
                <a:gridCol w="660400">
                  <a:extLst>
                    <a:ext uri="{9D8B030D-6E8A-4147-A177-3AD203B41FA5}">
                      <a16:colId xmlns:a16="http://schemas.microsoft.com/office/drawing/2014/main" val="398531899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3478976908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1782011964"/>
                    </a:ext>
                  </a:extLst>
                </a:gridCol>
              </a:tblGrid>
              <a:tr h="2090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ample #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MSO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stradiol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4963521"/>
                  </a:ext>
                </a:extLst>
              </a:tr>
              <a:tr h="2090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9520179"/>
                  </a:ext>
                </a:extLst>
              </a:tr>
              <a:tr h="2033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.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2200368"/>
                  </a:ext>
                </a:extLst>
              </a:tr>
              <a:tr h="2033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8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7248262"/>
                  </a:ext>
                </a:extLst>
              </a:tr>
              <a:tr h="2033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.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8484295"/>
                  </a:ext>
                </a:extLst>
              </a:tr>
              <a:tr h="2033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0447616"/>
                  </a:ext>
                </a:extLst>
              </a:tr>
              <a:tr h="2033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82209707"/>
                  </a:ext>
                </a:extLst>
              </a:tr>
              <a:tr h="2033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7379586"/>
                  </a:ext>
                </a:extLst>
              </a:tr>
              <a:tr h="2033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.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4796380"/>
                  </a:ext>
                </a:extLst>
              </a:tr>
              <a:tr h="2033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3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9408196"/>
                  </a:ext>
                </a:extLst>
              </a:tr>
            </a:tbl>
          </a:graphicData>
        </a:graphic>
      </p:graphicFrame>
      <p:graphicFrame>
        <p:nvGraphicFramePr>
          <p:cNvPr id="11" name="表 10">
            <a:extLst>
              <a:ext uri="{FF2B5EF4-FFF2-40B4-BE49-F238E27FC236}">
                <a16:creationId xmlns:a16="http://schemas.microsoft.com/office/drawing/2014/main" id="{DF1EE0C2-391D-4AF4-848F-B89D1098CCD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11798604"/>
              </p:ext>
            </p:extLst>
          </p:nvPr>
        </p:nvGraphicFramePr>
        <p:xfrm>
          <a:off x="4077630" y="2488234"/>
          <a:ext cx="1981200" cy="1841502"/>
        </p:xfrm>
        <a:graphic>
          <a:graphicData uri="http://schemas.openxmlformats.org/drawingml/2006/table">
            <a:tbl>
              <a:tblPr/>
              <a:tblGrid>
                <a:gridCol w="660400">
                  <a:extLst>
                    <a:ext uri="{9D8B030D-6E8A-4147-A177-3AD203B41FA5}">
                      <a16:colId xmlns:a16="http://schemas.microsoft.com/office/drawing/2014/main" val="3102893103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1607405259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1218135165"/>
                    </a:ext>
                  </a:extLst>
                </a:gridCol>
              </a:tblGrid>
              <a:tr h="2090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ample #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MSO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stradiol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5230230"/>
                  </a:ext>
                </a:extLst>
              </a:tr>
              <a:tr h="20900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05.5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33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1542592"/>
                  </a:ext>
                </a:extLst>
              </a:tr>
              <a:tr h="2033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7.0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3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7426445"/>
                  </a:ext>
                </a:extLst>
              </a:tr>
              <a:tr h="2033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09.8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22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9128942"/>
                  </a:ext>
                </a:extLst>
              </a:tr>
              <a:tr h="2033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04.0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15.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313728"/>
                  </a:ext>
                </a:extLst>
              </a:tr>
              <a:tr h="2033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08.7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74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049107"/>
                  </a:ext>
                </a:extLst>
              </a:tr>
              <a:tr h="2033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42.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89.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4555557"/>
                  </a:ext>
                </a:extLst>
              </a:tr>
              <a:tr h="20335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21.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33.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5710982"/>
                  </a:ext>
                </a:extLst>
              </a:tr>
              <a:tr h="2033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54.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23.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1588656"/>
                  </a:ext>
                </a:extLst>
              </a:tr>
            </a:tbl>
          </a:graphicData>
        </a:graphic>
      </p:graphicFrame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4C3066E-2124-4B3A-A634-79A06F62DFAE}"/>
              </a:ext>
            </a:extLst>
          </p:cNvPr>
          <p:cNvSpPr txBox="1"/>
          <p:nvPr/>
        </p:nvSpPr>
        <p:spPr>
          <a:xfrm>
            <a:off x="3591936" y="2184052"/>
            <a:ext cx="23058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PGE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4" name="表 13">
            <a:extLst>
              <a:ext uri="{FF2B5EF4-FFF2-40B4-BE49-F238E27FC236}">
                <a16:creationId xmlns:a16="http://schemas.microsoft.com/office/drawing/2014/main" id="{633FAB34-FE47-4EF9-B7B0-908C0DEE818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55286896"/>
              </p:ext>
            </p:extLst>
          </p:nvPr>
        </p:nvGraphicFramePr>
        <p:xfrm>
          <a:off x="634423" y="4957247"/>
          <a:ext cx="5915026" cy="2367613"/>
        </p:xfrm>
        <a:graphic>
          <a:graphicData uri="http://schemas.openxmlformats.org/drawingml/2006/table">
            <a:tbl>
              <a:tblPr/>
              <a:tblGrid>
                <a:gridCol w="708712">
                  <a:extLst>
                    <a:ext uri="{9D8B030D-6E8A-4147-A177-3AD203B41FA5}">
                      <a16:colId xmlns:a16="http://schemas.microsoft.com/office/drawing/2014/main" val="4015589388"/>
                    </a:ext>
                  </a:extLst>
                </a:gridCol>
                <a:gridCol w="1117585">
                  <a:extLst>
                    <a:ext uri="{9D8B030D-6E8A-4147-A177-3AD203B41FA5}">
                      <a16:colId xmlns:a16="http://schemas.microsoft.com/office/drawing/2014/main" val="3737341206"/>
                    </a:ext>
                  </a:extLst>
                </a:gridCol>
                <a:gridCol w="1117585">
                  <a:extLst>
                    <a:ext uri="{9D8B030D-6E8A-4147-A177-3AD203B41FA5}">
                      <a16:colId xmlns:a16="http://schemas.microsoft.com/office/drawing/2014/main" val="2517827453"/>
                    </a:ext>
                  </a:extLst>
                </a:gridCol>
                <a:gridCol w="742786">
                  <a:extLst>
                    <a:ext uri="{9D8B030D-6E8A-4147-A177-3AD203B41FA5}">
                      <a16:colId xmlns:a16="http://schemas.microsoft.com/office/drawing/2014/main" val="3576455033"/>
                    </a:ext>
                  </a:extLst>
                </a:gridCol>
                <a:gridCol w="742786">
                  <a:extLst>
                    <a:ext uri="{9D8B030D-6E8A-4147-A177-3AD203B41FA5}">
                      <a16:colId xmlns:a16="http://schemas.microsoft.com/office/drawing/2014/main" val="2883159324"/>
                    </a:ext>
                  </a:extLst>
                </a:gridCol>
                <a:gridCol w="742786">
                  <a:extLst>
                    <a:ext uri="{9D8B030D-6E8A-4147-A177-3AD203B41FA5}">
                      <a16:colId xmlns:a16="http://schemas.microsoft.com/office/drawing/2014/main" val="2653296214"/>
                    </a:ext>
                  </a:extLst>
                </a:gridCol>
                <a:gridCol w="742786">
                  <a:extLst>
                    <a:ext uri="{9D8B030D-6E8A-4147-A177-3AD203B41FA5}">
                      <a16:colId xmlns:a16="http://schemas.microsoft.com/office/drawing/2014/main" val="2817583714"/>
                    </a:ext>
                  </a:extLst>
                </a:gridCol>
              </a:tblGrid>
              <a:tr h="16978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ample #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MSO</a:t>
                      </a:r>
                    </a:p>
                  </a:txBody>
                  <a:tcPr marL="5437" marR="5437" marT="54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stradiol</a:t>
                      </a:r>
                    </a:p>
                  </a:txBody>
                  <a:tcPr marL="5437" marR="5437" marT="5437" marB="0" anchor="ctr">
                    <a:lnL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stradiol +</a:t>
                      </a:r>
                    </a:p>
                  </a:txBody>
                  <a:tcPr marL="5437" marR="5437" marT="5437" marB="0" anchor="ctr">
                    <a:lnL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26055475"/>
                  </a:ext>
                </a:extLst>
              </a:tr>
              <a:tr h="30291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P1 antagonist</a:t>
                      </a:r>
                    </a:p>
                  </a:txBody>
                  <a:tcPr marL="5437" marR="5437" marT="5437" marB="0" anchor="ctr">
                    <a:lnL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P2 antagonist</a:t>
                      </a:r>
                    </a:p>
                  </a:txBody>
                  <a:tcPr marL="5437" marR="5437" marT="5437" marB="0" anchor="ctr">
                    <a:lnL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P3 antagonist</a:t>
                      </a:r>
                    </a:p>
                  </a:txBody>
                  <a:tcPr marL="5437" marR="5437" marT="5437" marB="0" anchor="ctr">
                    <a:lnL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P4 antagonist</a:t>
                      </a:r>
                    </a:p>
                  </a:txBody>
                  <a:tcPr marL="5437" marR="5437" marT="5437" marB="0" anchor="ctr">
                    <a:lnL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5092451"/>
                  </a:ext>
                </a:extLst>
              </a:tr>
              <a:tr h="17450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9.9</a:t>
                      </a:r>
                    </a:p>
                  </a:txBody>
                  <a:tcPr marL="5437" marR="5437" marT="54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9.8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8.1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6.1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2.8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9.9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5358552"/>
                  </a:ext>
                </a:extLst>
              </a:tr>
              <a:tr h="16978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0.3</a:t>
                      </a:r>
                    </a:p>
                  </a:txBody>
                  <a:tcPr marL="5437" marR="5437" marT="54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4.0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0.3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3.8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3.8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18.4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5634639"/>
                  </a:ext>
                </a:extLst>
              </a:tr>
              <a:tr h="16978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6.3</a:t>
                      </a:r>
                    </a:p>
                  </a:txBody>
                  <a:tcPr marL="5437" marR="5437" marT="54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2.3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1.4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1.6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0.5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6.4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3124357"/>
                  </a:ext>
                </a:extLst>
              </a:tr>
              <a:tr h="16978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18.2</a:t>
                      </a:r>
                    </a:p>
                  </a:txBody>
                  <a:tcPr marL="5437" marR="5437" marT="54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8.9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.9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1.4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7.3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19.5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4046934"/>
                  </a:ext>
                </a:extLst>
              </a:tr>
              <a:tr h="16978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0.2</a:t>
                      </a:r>
                    </a:p>
                  </a:txBody>
                  <a:tcPr marL="5437" marR="5437" marT="54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0.0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6.7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4.6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1.5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9.9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2899722"/>
                  </a:ext>
                </a:extLst>
              </a:tr>
              <a:tr h="16978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6.1</a:t>
                      </a:r>
                    </a:p>
                  </a:txBody>
                  <a:tcPr marL="5437" marR="5437" marT="54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3.2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3.0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5.8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.3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01.9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1957752"/>
                  </a:ext>
                </a:extLst>
              </a:tr>
              <a:tr h="16978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2.6</a:t>
                      </a:r>
                    </a:p>
                  </a:txBody>
                  <a:tcPr marL="5437" marR="5437" marT="54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0.6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4.2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8.7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0.4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4.5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6783872"/>
                  </a:ext>
                </a:extLst>
              </a:tr>
              <a:tr h="16978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0.2</a:t>
                      </a:r>
                    </a:p>
                  </a:txBody>
                  <a:tcPr marL="5437" marR="5437" marT="54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0.4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4.5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3.9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3.2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7.7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0684682"/>
                  </a:ext>
                </a:extLst>
              </a:tr>
              <a:tr h="16978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7.2</a:t>
                      </a:r>
                    </a:p>
                  </a:txBody>
                  <a:tcPr marL="5437" marR="5437" marT="54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.7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1.9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1.8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9.8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5.1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92257"/>
                  </a:ext>
                </a:extLst>
              </a:tr>
              <a:tr h="16978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24.2</a:t>
                      </a:r>
                    </a:p>
                  </a:txBody>
                  <a:tcPr marL="5437" marR="5437" marT="54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4.6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8.6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5.8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3.4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12.1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1396144"/>
                  </a:ext>
                </a:extLst>
              </a:tr>
              <a:tr h="16978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verage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1.5</a:t>
                      </a:r>
                    </a:p>
                  </a:txBody>
                  <a:tcPr marL="5437" marR="5437" marT="543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1.8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4.7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6.4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6.6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34.5</a:t>
                      </a:r>
                    </a:p>
                  </a:txBody>
                  <a:tcPr marL="5437" marR="5437" marT="543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4404983"/>
                  </a:ext>
                </a:extLst>
              </a:tr>
            </a:tbl>
          </a:graphicData>
        </a:graphic>
      </p:graphicFrame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5C586AD-A457-4A2F-B5AB-05587D506C9B}"/>
              </a:ext>
            </a:extLst>
          </p:cNvPr>
          <p:cNvSpPr txBox="1"/>
          <p:nvPr/>
        </p:nvSpPr>
        <p:spPr>
          <a:xfrm>
            <a:off x="167269" y="4641571"/>
            <a:ext cx="29525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 IFN-γ (</a:t>
            </a:r>
            <a:r>
              <a:rPr kumimoji="1"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folds vs. no stimulation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3367787-1E0C-454E-9F9C-AD79F92BB878}"/>
              </a:ext>
            </a:extLst>
          </p:cNvPr>
          <p:cNvSpPr txBox="1"/>
          <p:nvPr/>
        </p:nvSpPr>
        <p:spPr>
          <a:xfrm>
            <a:off x="202409" y="7591273"/>
            <a:ext cx="6453182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>
                <a:cs typeface="Times New Roman" panose="02020603050405020304" pitchFamily="18" charset="0"/>
              </a:rPr>
              <a:t>Supplementary Table 3.</a:t>
            </a:r>
          </a:p>
          <a:p>
            <a:pPr algn="just"/>
            <a:r>
              <a:rPr lang="en-US" altLang="ja-JP" sz="1200" dirty="0">
                <a:cs typeface="Times New Roman" panose="02020603050405020304" pitchFamily="18" charset="0"/>
              </a:rPr>
              <a:t>The original data of immunosuppressive assay using estradiol, related to Figure 3.</a:t>
            </a:r>
          </a:p>
          <a:p>
            <a:pPr algn="just"/>
            <a:r>
              <a:rPr lang="en-US" altLang="ja-JP" sz="1200" dirty="0">
                <a:cs typeface="Times New Roman" panose="02020603050405020304" pitchFamily="18" charset="0"/>
              </a:rPr>
              <a:t>(a and b) IFN-γ production in the cultures of PBMCs from BLV-uninfected (a) and infected cattle (b) cultivated with anti-CD3 and anti-CD28 </a:t>
            </a:r>
            <a:r>
              <a:rPr lang="en-US" altLang="ja-JP" sz="1200" dirty="0" err="1">
                <a:cs typeface="Times New Roman" panose="02020603050405020304" pitchFamily="18" charset="0"/>
              </a:rPr>
              <a:t>mAbs</a:t>
            </a:r>
            <a:r>
              <a:rPr lang="en-US" altLang="ja-JP" sz="1200" dirty="0">
                <a:cs typeface="Times New Roman" panose="02020603050405020304" pitchFamily="18" charset="0"/>
              </a:rPr>
              <a:t> (a) and FLK-BLV (b), respectively. (c and d) </a:t>
            </a:r>
            <a:r>
              <a:rPr lang="en-US" altLang="ja-JP" sz="1200" i="1" dirty="0">
                <a:cs typeface="Times New Roman" panose="02020603050405020304" pitchFamily="18" charset="0"/>
              </a:rPr>
              <a:t>COX2</a:t>
            </a:r>
            <a:r>
              <a:rPr lang="en-US" altLang="ja-JP" sz="1200" dirty="0">
                <a:cs typeface="Times New Roman" panose="02020603050405020304" pitchFamily="18" charset="0"/>
              </a:rPr>
              <a:t> expression (c) and PGE</a:t>
            </a:r>
            <a:r>
              <a:rPr lang="en-US" altLang="ja-JP" sz="1200" baseline="-25000" dirty="0"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cs typeface="Times New Roman" panose="02020603050405020304" pitchFamily="18" charset="0"/>
              </a:rPr>
              <a:t> concentration (d) in PBMCs from BLV-uninfected cattle cultivated with estradiol. (e) IFN-γ production in PBMCs from BLV-uninfected cattle cultivated with each EP antagonist, estradiol, and anti-CD3 and anti-CD28 </a:t>
            </a:r>
            <a:r>
              <a:rPr lang="en-US" altLang="ja-JP" sz="1200" dirty="0" err="1">
                <a:cs typeface="Times New Roman" panose="02020603050405020304" pitchFamily="18" charset="0"/>
              </a:rPr>
              <a:t>mAbs</a:t>
            </a:r>
            <a:r>
              <a:rPr lang="en-US" altLang="ja-JP" sz="1200" dirty="0">
                <a:cs typeface="Times New Roman" panose="02020603050405020304" pitchFamily="18" charset="0"/>
              </a:rPr>
              <a:t>.  </a:t>
            </a:r>
          </a:p>
        </p:txBody>
      </p:sp>
    </p:spTree>
    <p:extLst>
      <p:ext uri="{BB962C8B-B14F-4D97-AF65-F5344CB8AC3E}">
        <p14:creationId xmlns:p14="http://schemas.microsoft.com/office/powerpoint/2010/main" val="30924543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per format">
      <a:majorFont>
        <a:latin typeface="Times New Roman"/>
        <a:ea typeface="ＭＳ 明朝"/>
        <a:cs typeface=""/>
      </a:majorFont>
      <a:minorFont>
        <a:latin typeface="Times New Roman"/>
        <a:ea typeface="ＭＳ 明朝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</TotalTime>
  <Words>356</Words>
  <Application>Microsoft Office PowerPoint</Application>
  <PresentationFormat>On-screen Show (4:3)</PresentationFormat>
  <Paragraphs>19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治木 大和</dc:creator>
  <cp:lastModifiedBy>Saranya Siva</cp:lastModifiedBy>
  <cp:revision>7</cp:revision>
  <dcterms:created xsi:type="dcterms:W3CDTF">2021-12-25T03:57:05Z</dcterms:created>
  <dcterms:modified xsi:type="dcterms:W3CDTF">2022-02-15T03:42:45Z</dcterms:modified>
</cp:coreProperties>
</file>